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103917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3" autoAdjust="0"/>
    <p:restoredTop sz="94696"/>
  </p:normalViewPr>
  <p:slideViewPr>
    <p:cSldViewPr snapToGrid="0">
      <p:cViewPr varScale="1">
        <p:scale>
          <a:sx n="105" d="100"/>
          <a:sy n="105" d="100"/>
        </p:scale>
        <p:origin x="14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7F312A-8007-4433-9479-D5661CCAF1CB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090613" y="1143000"/>
            <a:ext cx="467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EB4846-F501-43BA-8590-2F9438DAFAA8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8028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>
          <a:xfrm>
            <a:off x="1090613" y="1143000"/>
            <a:ext cx="4676775" cy="3086100"/>
          </a:xfrm>
        </p:spPr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l-NL" dirty="0"/>
              <a:t>Pijnintensiteit</a:t>
            </a:r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2079CB-32AF-421B-B952-98E711EF14D1}" type="slidenum">
              <a:rPr lang="nl-NL" smtClean="0"/>
              <a:t>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173078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9383" y="1122363"/>
            <a:ext cx="8833009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98972" y="3602038"/>
            <a:ext cx="7793831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87606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035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36615" y="365125"/>
            <a:ext cx="2240726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4435" y="365125"/>
            <a:ext cx="6592282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13652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55204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9023" y="1709740"/>
            <a:ext cx="8962906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9023" y="4589465"/>
            <a:ext cx="8962906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36713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4435" y="1825625"/>
            <a:ext cx="4416504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60836" y="1825625"/>
            <a:ext cx="4416504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4552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365127"/>
            <a:ext cx="8962906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5789" y="1681163"/>
            <a:ext cx="439620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5789" y="2505075"/>
            <a:ext cx="439620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60837" y="1681163"/>
            <a:ext cx="441785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60837" y="2505075"/>
            <a:ext cx="441785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96090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18440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55473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457200"/>
            <a:ext cx="335161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17858" y="987427"/>
            <a:ext cx="5260836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788" y="2057400"/>
            <a:ext cx="335161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7524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5788" y="457200"/>
            <a:ext cx="335161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17858" y="987427"/>
            <a:ext cx="5260836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5788" y="2057400"/>
            <a:ext cx="335161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28229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4435" y="365127"/>
            <a:ext cx="896290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435" y="1825625"/>
            <a:ext cx="896290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4435" y="6356352"/>
            <a:ext cx="233814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A4ED75-5E7A-4342-B809-90A3CF8D5E63}" type="datetimeFigureOut">
              <a:rPr lang="nl-NL" smtClean="0"/>
              <a:t>14-01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2276" y="6356352"/>
            <a:ext cx="350722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39191" y="6356352"/>
            <a:ext cx="233814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67DCD3-739D-4430-932F-B9BF2843574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2021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Afbeelding 2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3DA87174-B434-3C1F-D37B-15DC2A82CB4B}"/>
              </a:ext>
            </a:extLst>
          </p:cNvPr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8678" y="6240"/>
            <a:ext cx="3420000" cy="2268000"/>
          </a:xfrm>
          <a:prstGeom prst="rect">
            <a:avLst/>
          </a:prstGeom>
        </p:spPr>
      </p:pic>
      <p:pic>
        <p:nvPicPr>
          <p:cNvPr id="6" name="Afbeelding 5" descr="Afbeelding met tekst, diagram, lijn, Parallel&#10;&#10;Automatisch gegenereerde beschrijving">
            <a:extLst>
              <a:ext uri="{FF2B5EF4-FFF2-40B4-BE49-F238E27FC236}">
                <a16:creationId xmlns:a16="http://schemas.microsoft.com/office/drawing/2014/main" id="{C9B8890B-CB74-81E4-CA72-207D229FAD69}"/>
              </a:ext>
            </a:extLst>
          </p:cNvPr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426" y="4590000"/>
            <a:ext cx="3420000" cy="2268000"/>
          </a:xfrm>
          <a:prstGeom prst="rect">
            <a:avLst/>
          </a:prstGeom>
        </p:spPr>
      </p:pic>
      <p:pic>
        <p:nvPicPr>
          <p:cNvPr id="10" name="Afbeelding 9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2B40DE6C-4FAB-5589-AF32-F9B39018B76C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426" y="2311487"/>
            <a:ext cx="3420000" cy="2268000"/>
          </a:xfrm>
          <a:prstGeom prst="rect">
            <a:avLst/>
          </a:prstGeom>
        </p:spPr>
      </p:pic>
      <p:pic>
        <p:nvPicPr>
          <p:cNvPr id="14" name="Afbeelding 13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1690EAF4-63E9-339B-C14D-C5BF8675B284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3052" y="25173"/>
            <a:ext cx="3420000" cy="2268000"/>
          </a:xfrm>
          <a:prstGeom prst="rect">
            <a:avLst/>
          </a:prstGeom>
        </p:spPr>
      </p:pic>
      <p:pic>
        <p:nvPicPr>
          <p:cNvPr id="17" name="Afbeelding 16" descr="Afbeelding met tekst, diagram, lijn, Technische tekening&#10;&#10;Automatisch gegenereerde beschrijving">
            <a:extLst>
              <a:ext uri="{FF2B5EF4-FFF2-40B4-BE49-F238E27FC236}">
                <a16:creationId xmlns:a16="http://schemas.microsoft.com/office/drawing/2014/main" id="{2B74CC46-2B86-C6E9-D235-C8B874397D18}"/>
              </a:ext>
            </a:extLst>
          </p:cNvPr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72000"/>
            <a:ext cx="3420000" cy="2268000"/>
          </a:xfrm>
          <a:prstGeom prst="rect">
            <a:avLst/>
          </a:prstGeom>
        </p:spPr>
      </p:pic>
      <p:pic>
        <p:nvPicPr>
          <p:cNvPr id="19" name="Afbeelding 18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E97B8FC3-13DD-4F3B-B2E4-DF506D7A3C1D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22000"/>
            <a:ext cx="3420000" cy="2268000"/>
          </a:xfrm>
          <a:prstGeom prst="rect">
            <a:avLst/>
          </a:prstGeom>
        </p:spPr>
      </p:pic>
      <p:pic>
        <p:nvPicPr>
          <p:cNvPr id="30" name="Afbeelding 29" descr="Afbeelding met tekst, diagram, lijn, Perceel&#10;&#10;Automatisch gegenereerde beschrijving">
            <a:extLst>
              <a:ext uri="{FF2B5EF4-FFF2-40B4-BE49-F238E27FC236}">
                <a16:creationId xmlns:a16="http://schemas.microsoft.com/office/drawing/2014/main" id="{C488871F-71A8-4469-921E-B8062EC4FAB1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5792"/>
            <a:ext cx="3420000" cy="2268000"/>
          </a:xfrm>
          <a:prstGeom prst="rect">
            <a:avLst/>
          </a:prstGeom>
        </p:spPr>
      </p:pic>
      <p:sp>
        <p:nvSpPr>
          <p:cNvPr id="23" name="Tekstvak 22">
            <a:extLst>
              <a:ext uri="{FF2B5EF4-FFF2-40B4-BE49-F238E27FC236}">
                <a16:creationId xmlns:a16="http://schemas.microsoft.com/office/drawing/2014/main" id="{42978251-2670-6908-4F64-88BC19B27A47}"/>
              </a:ext>
            </a:extLst>
          </p:cNvPr>
          <p:cNvSpPr txBox="1">
            <a:spLocks/>
          </p:cNvSpPr>
          <p:nvPr/>
        </p:nvSpPr>
        <p:spPr>
          <a:xfrm>
            <a:off x="756001" y="330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1</a:t>
            </a:r>
          </a:p>
        </p:txBody>
      </p:sp>
      <p:sp>
        <p:nvSpPr>
          <p:cNvPr id="24" name="Tekstvak 23">
            <a:extLst>
              <a:ext uri="{FF2B5EF4-FFF2-40B4-BE49-F238E27FC236}">
                <a16:creationId xmlns:a16="http://schemas.microsoft.com/office/drawing/2014/main" id="{95486060-E2E6-7A43-F4A5-3082074851FA}"/>
              </a:ext>
            </a:extLst>
          </p:cNvPr>
          <p:cNvSpPr txBox="1">
            <a:spLocks/>
          </p:cNvSpPr>
          <p:nvPr/>
        </p:nvSpPr>
        <p:spPr>
          <a:xfrm>
            <a:off x="756001" y="2634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2</a:t>
            </a:r>
          </a:p>
        </p:txBody>
      </p:sp>
      <p:sp>
        <p:nvSpPr>
          <p:cNvPr id="25" name="Tekstvak 24">
            <a:extLst>
              <a:ext uri="{FF2B5EF4-FFF2-40B4-BE49-F238E27FC236}">
                <a16:creationId xmlns:a16="http://schemas.microsoft.com/office/drawing/2014/main" id="{345551D2-716B-94DE-1E21-C2876CBEF540}"/>
              </a:ext>
            </a:extLst>
          </p:cNvPr>
          <p:cNvSpPr txBox="1">
            <a:spLocks/>
          </p:cNvSpPr>
          <p:nvPr/>
        </p:nvSpPr>
        <p:spPr>
          <a:xfrm>
            <a:off x="4248001" y="330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4</a:t>
            </a:r>
          </a:p>
        </p:txBody>
      </p:sp>
      <p:sp>
        <p:nvSpPr>
          <p:cNvPr id="26" name="Tekstvak 25">
            <a:extLst>
              <a:ext uri="{FF2B5EF4-FFF2-40B4-BE49-F238E27FC236}">
                <a16:creationId xmlns:a16="http://schemas.microsoft.com/office/drawing/2014/main" id="{4A37D714-AB48-B4A3-6278-8524BF071638}"/>
              </a:ext>
            </a:extLst>
          </p:cNvPr>
          <p:cNvSpPr txBox="1">
            <a:spLocks/>
          </p:cNvSpPr>
          <p:nvPr/>
        </p:nvSpPr>
        <p:spPr>
          <a:xfrm>
            <a:off x="756001" y="4866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3</a:t>
            </a:r>
          </a:p>
        </p:txBody>
      </p:sp>
      <p:sp>
        <p:nvSpPr>
          <p:cNvPr id="27" name="Tekstvak 26">
            <a:extLst>
              <a:ext uri="{FF2B5EF4-FFF2-40B4-BE49-F238E27FC236}">
                <a16:creationId xmlns:a16="http://schemas.microsoft.com/office/drawing/2014/main" id="{C283A2EA-2B6F-2D93-0251-2AE457794BD1}"/>
              </a:ext>
            </a:extLst>
          </p:cNvPr>
          <p:cNvSpPr txBox="1">
            <a:spLocks/>
          </p:cNvSpPr>
          <p:nvPr/>
        </p:nvSpPr>
        <p:spPr>
          <a:xfrm>
            <a:off x="7704001" y="330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7</a:t>
            </a:r>
          </a:p>
        </p:txBody>
      </p:sp>
      <p:sp>
        <p:nvSpPr>
          <p:cNvPr id="28" name="Tekstvak 27">
            <a:extLst>
              <a:ext uri="{FF2B5EF4-FFF2-40B4-BE49-F238E27FC236}">
                <a16:creationId xmlns:a16="http://schemas.microsoft.com/office/drawing/2014/main" id="{8C93277B-152B-B6D1-97D7-3BC8FD5BD6DF}"/>
              </a:ext>
            </a:extLst>
          </p:cNvPr>
          <p:cNvSpPr txBox="1">
            <a:spLocks/>
          </p:cNvSpPr>
          <p:nvPr/>
        </p:nvSpPr>
        <p:spPr>
          <a:xfrm>
            <a:off x="4248001" y="2634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5</a:t>
            </a:r>
          </a:p>
        </p:txBody>
      </p:sp>
      <p:sp>
        <p:nvSpPr>
          <p:cNvPr id="29" name="Tekstvak 28">
            <a:extLst>
              <a:ext uri="{FF2B5EF4-FFF2-40B4-BE49-F238E27FC236}">
                <a16:creationId xmlns:a16="http://schemas.microsoft.com/office/drawing/2014/main" id="{F7C3DCA1-241C-7A56-1ED0-9D6EB2713E2E}"/>
              </a:ext>
            </a:extLst>
          </p:cNvPr>
          <p:cNvSpPr txBox="1">
            <a:spLocks/>
          </p:cNvSpPr>
          <p:nvPr/>
        </p:nvSpPr>
        <p:spPr>
          <a:xfrm>
            <a:off x="4248001" y="4866240"/>
            <a:ext cx="11938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600" dirty="0"/>
              <a:t>Participant 6</a:t>
            </a:r>
          </a:p>
        </p:txBody>
      </p:sp>
    </p:spTree>
    <p:extLst>
      <p:ext uri="{BB962C8B-B14F-4D97-AF65-F5344CB8AC3E}">
        <p14:creationId xmlns:p14="http://schemas.microsoft.com/office/powerpoint/2010/main" val="1162380814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Kantoorth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</Words>
  <Application>Microsoft Macintosh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Kantoorth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yl Slatman</dc:creator>
  <cp:lastModifiedBy>Mengfei Sun</cp:lastModifiedBy>
  <cp:revision>6</cp:revision>
  <dcterms:created xsi:type="dcterms:W3CDTF">2024-09-23T09:31:16Z</dcterms:created>
  <dcterms:modified xsi:type="dcterms:W3CDTF">2025-01-14T21:04:09Z</dcterms:modified>
</cp:coreProperties>
</file>